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9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4" d="100"/>
          <a:sy n="54" d="100"/>
        </p:scale>
        <p:origin x="2424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07" t="8672" r="18139" b="5070"/>
          <a:stretch/>
        </p:blipFill>
        <p:spPr>
          <a:xfrm>
            <a:off x="421569" y="1711331"/>
            <a:ext cx="2931231" cy="2901574"/>
          </a:xfrm>
          <a:prstGeom prst="rect">
            <a:avLst/>
          </a:prstGeom>
        </p:spPr>
      </p:pic>
      <p:sp>
        <p:nvSpPr>
          <p:cNvPr id="2" name="TextBox 3"/>
          <p:cNvSpPr txBox="1"/>
          <p:nvPr/>
        </p:nvSpPr>
        <p:spPr>
          <a:xfrm>
            <a:off x="40574" y="32657"/>
            <a:ext cx="660158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Heat-maps presenting the correlation  patterns of principal components with the markers in different tissues.</a:t>
            </a:r>
            <a:endParaRPr lang="el-GR"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406670" y="1219200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Thymus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41" t="6880" r="18254" b="3990"/>
          <a:stretch/>
        </p:blipFill>
        <p:spPr>
          <a:xfrm>
            <a:off x="3576628" y="1706248"/>
            <a:ext cx="3065532" cy="2998217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3661220" y="1592715"/>
            <a:ext cx="919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DCpp65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5714386" y="4569023"/>
            <a:ext cx="828859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uppieren 10"/>
          <p:cNvGrpSpPr/>
          <p:nvPr/>
        </p:nvGrpSpPr>
        <p:grpSpPr>
          <a:xfrm>
            <a:off x="3536371" y="4913241"/>
            <a:ext cx="3204723" cy="3849759"/>
            <a:chOff x="3569417" y="569841"/>
            <a:chExt cx="3204723" cy="3849759"/>
          </a:xfrm>
        </p:grpSpPr>
        <p:sp>
          <p:nvSpPr>
            <p:cNvPr id="15" name="TextBox 11"/>
            <p:cNvSpPr txBox="1"/>
            <p:nvPr/>
          </p:nvSpPr>
          <p:spPr>
            <a:xfrm>
              <a:off x="3569417" y="569841"/>
              <a:ext cx="320472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D. Peripheral  + Mesenteric </a:t>
              </a:r>
            </a:p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LNs</a:t>
              </a:r>
              <a:endParaRPr lang="de-DE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31" t="7749" r="18139" b="3830"/>
            <a:stretch/>
          </p:blipFill>
          <p:spPr>
            <a:xfrm>
              <a:off x="3722657" y="1301447"/>
              <a:ext cx="2952547" cy="2974349"/>
            </a:xfrm>
            <a:prstGeom prst="rect">
              <a:avLst/>
            </a:prstGeom>
          </p:spPr>
        </p:pic>
        <p:sp>
          <p:nvSpPr>
            <p:cNvPr id="14" name="Textfeld 13"/>
            <p:cNvSpPr txBox="1"/>
            <p:nvPr/>
          </p:nvSpPr>
          <p:spPr>
            <a:xfrm>
              <a:off x="3592989" y="1176464"/>
              <a:ext cx="91082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DCpp65</a:t>
              </a:r>
              <a:endParaRPr lang="de-D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5808341" y="4111823"/>
              <a:ext cx="821059" cy="3077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286075" y="1207567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Bone Marrow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95824" y="1540210"/>
            <a:ext cx="91082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DCpp65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2529424" y="4491498"/>
            <a:ext cx="821059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unde Klammer links 33"/>
          <p:cNvSpPr/>
          <p:nvPr/>
        </p:nvSpPr>
        <p:spPr>
          <a:xfrm>
            <a:off x="350105" y="1849831"/>
            <a:ext cx="45719" cy="966992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24" name="Gruppieren 23"/>
          <p:cNvGrpSpPr/>
          <p:nvPr/>
        </p:nvGrpSpPr>
        <p:grpSpPr>
          <a:xfrm>
            <a:off x="240189" y="4913241"/>
            <a:ext cx="3188811" cy="3801168"/>
            <a:chOff x="3440589" y="4800600"/>
            <a:chExt cx="3188811" cy="3801168"/>
          </a:xfrm>
        </p:grpSpPr>
        <p:sp>
          <p:nvSpPr>
            <p:cNvPr id="16" name="TextBox 12"/>
            <p:cNvSpPr txBox="1"/>
            <p:nvPr/>
          </p:nvSpPr>
          <p:spPr>
            <a:xfrm>
              <a:off x="3440589" y="4800600"/>
              <a:ext cx="12362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. Spleen</a:t>
              </a:r>
              <a:endParaRPr lang="de-DE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28" t="7340" r="19077" b="4258"/>
            <a:stretch/>
          </p:blipFill>
          <p:spPr>
            <a:xfrm>
              <a:off x="3569417" y="5474218"/>
              <a:ext cx="3059983" cy="2973662"/>
            </a:xfrm>
            <a:prstGeom prst="rect">
              <a:avLst/>
            </a:prstGeom>
          </p:spPr>
        </p:pic>
        <p:sp>
          <p:nvSpPr>
            <p:cNvPr id="19" name="Textfeld 18"/>
            <p:cNvSpPr txBox="1"/>
            <p:nvPr/>
          </p:nvSpPr>
          <p:spPr>
            <a:xfrm>
              <a:off x="3440589" y="5354631"/>
              <a:ext cx="91082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DCpp65</a:t>
              </a:r>
              <a:endParaRPr lang="de-D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5736783" y="8293991"/>
              <a:ext cx="821059" cy="3077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Rechteck 24"/>
          <p:cNvSpPr/>
          <p:nvPr/>
        </p:nvSpPr>
        <p:spPr>
          <a:xfrm>
            <a:off x="1074715" y="1900492"/>
            <a:ext cx="1859004" cy="1837816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6" name="Rechteck 55"/>
          <p:cNvSpPr/>
          <p:nvPr/>
        </p:nvSpPr>
        <p:spPr>
          <a:xfrm>
            <a:off x="4572000" y="1981200"/>
            <a:ext cx="1613825" cy="1626970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7" name="Rechteck 56"/>
          <p:cNvSpPr/>
          <p:nvPr/>
        </p:nvSpPr>
        <p:spPr>
          <a:xfrm>
            <a:off x="1027585" y="5867400"/>
            <a:ext cx="1953266" cy="1837816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8" name="Rechteck 57"/>
          <p:cNvSpPr/>
          <p:nvPr/>
        </p:nvSpPr>
        <p:spPr>
          <a:xfrm>
            <a:off x="4572000" y="5917320"/>
            <a:ext cx="1613825" cy="1626970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5530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A036DC05C6A1A459D0045F3A5BFA455" ma:contentTypeVersion="7" ma:contentTypeDescription="Create a new document." ma:contentTypeScope="" ma:versionID="79e4b1e9ad6462c332b2a675b59e1bfa">
  <xsd:schema xmlns:xsd="http://www.w3.org/2001/XMLSchema" xmlns:p="http://schemas.microsoft.com/office/2006/metadata/properties" xmlns:ns2="264b75e8-4cea-4aca-92d2-fe78d4dbc99d" targetNamespace="http://schemas.microsoft.com/office/2006/metadata/properties" ma:root="true" ma:fieldsID="89d1ce14b63a5a1181b7cd68a8134d12" ns2:_="">
    <xsd:import namespace="264b75e8-4cea-4aca-92d2-fe78d4dbc99d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64b75e8-4cea-4aca-92d2-fe78d4dbc99d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StageName xmlns="264b75e8-4cea-4aca-92d2-fe78d4dbc99d" xsi:nil="true"/>
    <IsDeleted xmlns="264b75e8-4cea-4aca-92d2-fe78d4dbc99d">false</IsDeleted>
    <DocumentType xmlns="264b75e8-4cea-4aca-92d2-fe78d4dbc99d">Presentation</DocumentType>
    <FileFormat xmlns="264b75e8-4cea-4aca-92d2-fe78d4dbc99d">PPTX</FileFormat>
    <DocumentId xmlns="264b75e8-4cea-4aca-92d2-fe78d4dbc99d">Presentation 2.PPTX</DocumentId>
    <Checked_x0020_Out_x0020_To xmlns="264b75e8-4cea-4aca-92d2-fe78d4dbc99d">
      <UserInfo>
        <DisplayName/>
        <AccountId xsi:nil="true"/>
        <AccountType/>
      </UserInfo>
    </Checked_x0020_Out_x0020_To>
    <TitleName xmlns="264b75e8-4cea-4aca-92d2-fe78d4dbc99d">Presentation 2.PPTX</TitleName>
  </documentManagement>
</p:properties>
</file>

<file path=customXml/itemProps1.xml><?xml version="1.0" encoding="utf-8"?>
<ds:datastoreItem xmlns:ds="http://schemas.openxmlformats.org/officeDocument/2006/customXml" ds:itemID="{0AD19BB8-D7C1-4E0C-B2A7-A4FE1B3C239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4466A5E-D761-4FAF-9539-43C20DF5AB7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64b75e8-4cea-4aca-92d2-fe78d4dbc99d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992227C7-FA5C-4CA4-9615-99EC875BBFDA}">
  <ds:schemaRefs>
    <ds:schemaRef ds:uri="http://schemas.microsoft.com/office/2006/metadata/properties"/>
    <ds:schemaRef ds:uri="264b75e8-4cea-4aca-92d2-fe78d4dbc99d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2006/documentManagement/types"/>
    <ds:schemaRef ds:uri="http://purl.org/dc/elements/1.1/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lk, Valery</dc:creator>
  <cp:lastModifiedBy>Elsa Carron</cp:lastModifiedBy>
  <cp:revision>27</cp:revision>
  <dcterms:created xsi:type="dcterms:W3CDTF">2006-08-16T00:00:00Z</dcterms:created>
  <dcterms:modified xsi:type="dcterms:W3CDTF">2017-11-28T15:33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A036DC05C6A1A459D0045F3A5BFA455</vt:lpwstr>
  </property>
</Properties>
</file>